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85" r:id="rId2"/>
  </p:sldIdLst>
  <p:sldSz cx="6858000" cy="9906000" type="A4"/>
  <p:notesSz cx="7099300" cy="10234613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6699"/>
    <a:srgbClr val="000000"/>
    <a:srgbClr val="60A0DA"/>
    <a:srgbClr val="EC7728"/>
    <a:srgbClr val="EE8640"/>
    <a:srgbClr val="9D999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等深淺樣式 2 - 輔色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1029" autoAdjust="0"/>
    <p:restoredTop sz="94660"/>
  </p:normalViewPr>
  <p:slideViewPr>
    <p:cSldViewPr snapToGrid="0">
      <p:cViewPr varScale="1">
        <p:scale>
          <a:sx n="49" d="100"/>
          <a:sy n="49" d="100"/>
        </p:scale>
        <p:origin x="2442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-51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henghsunho\Desktop\12&#24180;&#20998;&#26512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chenghsunho\Desktop\&#21152;&#20837;2017-2018&#20998;&#26512;\12&#24180;&#20998;&#26512;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TW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v>Drug susceptible</c:v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年齡和單一藥物抗藥性!$B$55:$H$55</c:f>
                <c:numCache>
                  <c:formatCode>General</c:formatCode>
                  <c:ptCount val="7"/>
                  <c:pt idx="0">
                    <c:v>21.084048861410793</c:v>
                  </c:pt>
                  <c:pt idx="1">
                    <c:v>21.743930689227938</c:v>
                  </c:pt>
                  <c:pt idx="2">
                    <c:v>20.88488814038983</c:v>
                  </c:pt>
                  <c:pt idx="3">
                    <c:v>21.541652498680492</c:v>
                  </c:pt>
                  <c:pt idx="4">
                    <c:v>21.46357296993736</c:v>
                  </c:pt>
                  <c:pt idx="5">
                    <c:v>21.310970438006347</c:v>
                  </c:pt>
                  <c:pt idx="6">
                    <c:v>21.255341246854979</c:v>
                  </c:pt>
                </c:numCache>
              </c:numRef>
            </c:plus>
            <c:minus>
              <c:numRef>
                <c:f>年齡和單一藥物抗藥性!$B$55:$H$55</c:f>
                <c:numCache>
                  <c:formatCode>General</c:formatCode>
                  <c:ptCount val="7"/>
                  <c:pt idx="0">
                    <c:v>21.084048861410793</c:v>
                  </c:pt>
                  <c:pt idx="1">
                    <c:v>21.743930689227938</c:v>
                  </c:pt>
                  <c:pt idx="2">
                    <c:v>20.88488814038983</c:v>
                  </c:pt>
                  <c:pt idx="3">
                    <c:v>21.541652498680492</c:v>
                  </c:pt>
                  <c:pt idx="4">
                    <c:v>21.46357296993736</c:v>
                  </c:pt>
                  <c:pt idx="5">
                    <c:v>21.310970438006347</c:v>
                  </c:pt>
                  <c:pt idx="6">
                    <c:v>21.255341246854979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年齡和單一藥物抗藥性!$B$51:$H$51</c:f>
              <c:strCache>
                <c:ptCount val="7"/>
                <c:pt idx="0">
                  <c:v>Ampicillin</c:v>
                </c:pt>
                <c:pt idx="1">
                  <c:v>Amoxicillin-clavulanate</c:v>
                </c:pt>
                <c:pt idx="2">
                  <c:v>Chloramphenicol</c:v>
                </c:pt>
                <c:pt idx="3">
                  <c:v>Cefotaxime</c:v>
                </c:pt>
                <c:pt idx="4">
                  <c:v>Cefuroxime</c:v>
                </c:pt>
                <c:pt idx="5">
                  <c:v>Levofloxacin</c:v>
                </c:pt>
                <c:pt idx="6">
                  <c:v>Trimethoprim-sulfamethoxazole</c:v>
                </c:pt>
              </c:strCache>
            </c:strRef>
          </c:cat>
          <c:val>
            <c:numRef>
              <c:f>年齡和單一藥物抗藥性!$B$52:$H$52</c:f>
              <c:numCache>
                <c:formatCode>0.0_);[Red]\(0.0\)</c:formatCode>
                <c:ptCount val="7"/>
                <c:pt idx="0">
                  <c:v>67.464409192249548</c:v>
                </c:pt>
                <c:pt idx="1">
                  <c:v>66.650910103710046</c:v>
                </c:pt>
                <c:pt idx="2">
                  <c:v>67.476748294874653</c:v>
                </c:pt>
                <c:pt idx="3">
                  <c:v>66.756508431183178</c:v>
                </c:pt>
                <c:pt idx="4">
                  <c:v>66.804425940216092</c:v>
                </c:pt>
                <c:pt idx="5">
                  <c:v>66.504513073150164</c:v>
                </c:pt>
                <c:pt idx="6">
                  <c:v>66.618122097699199</c:v>
                </c:pt>
              </c:numCache>
            </c:numRef>
          </c:val>
        </c:ser>
        <c:ser>
          <c:idx val="1"/>
          <c:order val="1"/>
          <c:tx>
            <c:v>Drug non-susceptible</c:v>
          </c:tx>
          <c:spPr>
            <a:solidFill>
              <a:srgbClr val="C00000"/>
            </a:solidFill>
            <a:ln>
              <a:noFill/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年齡和單一藥物抗藥性!$B$56:$H$56</c:f>
                <c:numCache>
                  <c:formatCode>General</c:formatCode>
                  <c:ptCount val="7"/>
                  <c:pt idx="0">
                    <c:v>21.818425607443611</c:v>
                  </c:pt>
                  <c:pt idx="1">
                    <c:v>20.19418840308504</c:v>
                  </c:pt>
                  <c:pt idx="2">
                    <c:v>23.487965639348594</c:v>
                  </c:pt>
                  <c:pt idx="3">
                    <c:v>19.812949178909069</c:v>
                  </c:pt>
                  <c:pt idx="4">
                    <c:v>21.919516150668677</c:v>
                  </c:pt>
                  <c:pt idx="5">
                    <c:v>22.536390248262162</c:v>
                  </c:pt>
                  <c:pt idx="6">
                    <c:v>21.695385413842221</c:v>
                  </c:pt>
                </c:numCache>
              </c:numRef>
            </c:plus>
            <c:minus>
              <c:numRef>
                <c:f>年齡和單一藥物抗藥性!$B$56:$H$56</c:f>
                <c:numCache>
                  <c:formatCode>General</c:formatCode>
                  <c:ptCount val="7"/>
                  <c:pt idx="0">
                    <c:v>21.818425607443611</c:v>
                  </c:pt>
                  <c:pt idx="1">
                    <c:v>20.19418840308504</c:v>
                  </c:pt>
                  <c:pt idx="2">
                    <c:v>23.487965639348594</c:v>
                  </c:pt>
                  <c:pt idx="3">
                    <c:v>19.812949178909069</c:v>
                  </c:pt>
                  <c:pt idx="4">
                    <c:v>21.919516150668677</c:v>
                  </c:pt>
                  <c:pt idx="5">
                    <c:v>22.536390248262162</c:v>
                  </c:pt>
                  <c:pt idx="6">
                    <c:v>21.69538541384222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年齡和單一藥物抗藥性!$B$51:$H$51</c:f>
              <c:strCache>
                <c:ptCount val="7"/>
                <c:pt idx="0">
                  <c:v>Ampicillin</c:v>
                </c:pt>
                <c:pt idx="1">
                  <c:v>Amoxicillin-clavulanate</c:v>
                </c:pt>
                <c:pt idx="2">
                  <c:v>Chloramphenicol</c:v>
                </c:pt>
                <c:pt idx="3">
                  <c:v>Cefotaxime</c:v>
                </c:pt>
                <c:pt idx="4">
                  <c:v>Cefuroxime</c:v>
                </c:pt>
                <c:pt idx="5">
                  <c:v>Levofloxacin</c:v>
                </c:pt>
                <c:pt idx="6">
                  <c:v>Trimethoprim-sulfamethoxazole</c:v>
                </c:pt>
              </c:strCache>
            </c:strRef>
          </c:cat>
          <c:val>
            <c:numRef>
              <c:f>年齡和單一藥物抗藥性!$B$53:$H$53</c:f>
              <c:numCache>
                <c:formatCode>0.0_);[Red]\(0.0\)</c:formatCode>
                <c:ptCount val="7"/>
                <c:pt idx="0">
                  <c:v>66.213113237973701</c:v>
                </c:pt>
                <c:pt idx="1">
                  <c:v>67.428570180492741</c:v>
                </c:pt>
                <c:pt idx="2">
                  <c:v>64.146759867397265</c:v>
                </c:pt>
                <c:pt idx="3">
                  <c:v>67.604483855178572</c:v>
                </c:pt>
                <c:pt idx="4">
                  <c:v>66.470825385506359</c:v>
                </c:pt>
                <c:pt idx="5">
                  <c:v>68.451661945661044</c:v>
                </c:pt>
                <c:pt idx="6">
                  <c:v>66.91180339417610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0"/>
        <c:axId val="452343960"/>
        <c:axId val="452344352"/>
      </c:barChart>
      <c:catAx>
        <c:axId val="45234396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5400000" spcFirstLastPara="1" vertOverflow="ellipsis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TW"/>
          </a:p>
        </c:txPr>
        <c:crossAx val="452344352"/>
        <c:crosses val="autoZero"/>
        <c:auto val="1"/>
        <c:lblAlgn val="ctr"/>
        <c:lblOffset val="100"/>
        <c:noMultiLvlLbl val="0"/>
      </c:catAx>
      <c:valAx>
        <c:axId val="452344352"/>
        <c:scaling>
          <c:orientation val="minMax"/>
          <c:max val="100"/>
          <c:min val="0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Age</a:t>
                </a:r>
              </a:p>
            </c:rich>
          </c:tx>
          <c:layout>
            <c:manualLayout>
              <c:xMode val="edge"/>
              <c:yMode val="edge"/>
              <c:x val="7.8395061728395062E-3"/>
              <c:y val="0.2216508871974452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zh-TW"/>
            </a:p>
          </c:txPr>
        </c:title>
        <c:numFmt formatCode="#,##0_);[Red]\(#,##0\)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TW"/>
          </a:p>
        </c:txPr>
        <c:crossAx val="452343960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zh-TW"/>
        </a:p>
      </c:txPr>
    </c:legend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4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zh-TW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TW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5483525605379528"/>
          <c:y val="4.2114406311651365E-2"/>
          <c:w val="0.82351360348749192"/>
          <c:h val="0.460614129409960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性別和單一藥物抗藥性!$AX$1</c:f>
              <c:strCache>
                <c:ptCount val="1"/>
                <c:pt idx="0">
                  <c:v>Male (n = 1436)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性別和單一藥物抗藥性!$AX$2:$BD$2</c:f>
              <c:strCache>
                <c:ptCount val="7"/>
                <c:pt idx="0">
                  <c:v>Ampicillin</c:v>
                </c:pt>
                <c:pt idx="1">
                  <c:v>Amoxicillin-clavulanate</c:v>
                </c:pt>
                <c:pt idx="2">
                  <c:v>Chloramphenicol</c:v>
                </c:pt>
                <c:pt idx="3">
                  <c:v>Cefotaxime</c:v>
                </c:pt>
                <c:pt idx="4">
                  <c:v>Cefuroxime</c:v>
                </c:pt>
                <c:pt idx="5">
                  <c:v>Levofloxacin</c:v>
                </c:pt>
                <c:pt idx="6">
                  <c:v>Trimethoprim-sulfamethoxazole</c:v>
                </c:pt>
              </c:strCache>
            </c:strRef>
          </c:cat>
          <c:val>
            <c:numRef>
              <c:f>(性別和單一藥物抗藥性!$F$5,性別和單一藥物抗藥性!$M$5,性別和單一藥物抗藥性!$T$5,性別和單一藥物抗藥性!$AA$5,性別和單一藥物抗藥性!$AH$5,性別和單一藥物抗藥性!$AO$5,性別和單一藥物抗藥性!$AV$5)</c:f>
              <c:numCache>
                <c:formatCode>General</c:formatCode>
                <c:ptCount val="7"/>
                <c:pt idx="0">
                  <c:v>0.5725190839694656</c:v>
                </c:pt>
                <c:pt idx="1">
                  <c:v>0.16335877862595419</c:v>
                </c:pt>
                <c:pt idx="2">
                  <c:v>0.23511450381679388</c:v>
                </c:pt>
                <c:pt idx="3">
                  <c:v>3.3587786259541987E-2</c:v>
                </c:pt>
                <c:pt idx="4">
                  <c:v>7.6335877862595422E-2</c:v>
                </c:pt>
                <c:pt idx="5">
                  <c:v>0.15725190839694655</c:v>
                </c:pt>
                <c:pt idx="6">
                  <c:v>0.58015267175572516</c:v>
                </c:pt>
              </c:numCache>
            </c:numRef>
          </c:val>
        </c:ser>
        <c:ser>
          <c:idx val="1"/>
          <c:order val="1"/>
          <c:tx>
            <c:strRef>
              <c:f>性別和單一藥物抗藥性!$AY$1</c:f>
              <c:strCache>
                <c:ptCount val="1"/>
                <c:pt idx="0">
                  <c:v>Female (n = 655)</c:v>
                </c:pt>
              </c:strCache>
            </c:strRef>
          </c:tx>
          <c:spPr>
            <a:solidFill>
              <a:srgbClr val="C00000"/>
            </a:solidFill>
            <a:ln>
              <a:noFill/>
            </a:ln>
            <a:effectLst/>
          </c:spPr>
          <c:invertIfNegative val="0"/>
          <c:cat>
            <c:strRef>
              <c:f>性別和單一藥物抗藥性!$AX$2:$BD$2</c:f>
              <c:strCache>
                <c:ptCount val="7"/>
                <c:pt idx="0">
                  <c:v>Ampicillin</c:v>
                </c:pt>
                <c:pt idx="1">
                  <c:v>Amoxicillin-clavulanate</c:v>
                </c:pt>
                <c:pt idx="2">
                  <c:v>Chloramphenicol</c:v>
                </c:pt>
                <c:pt idx="3">
                  <c:v>Cefotaxime</c:v>
                </c:pt>
                <c:pt idx="4">
                  <c:v>Cefuroxime</c:v>
                </c:pt>
                <c:pt idx="5">
                  <c:v>Levofloxacin</c:v>
                </c:pt>
                <c:pt idx="6">
                  <c:v>Trimethoprim-sulfamethoxazole</c:v>
                </c:pt>
              </c:strCache>
            </c:strRef>
          </c:cat>
          <c:val>
            <c:numRef>
              <c:f>(性別和單一藥物抗藥性!$F$6,性別和單一藥物抗藥性!$M$6,性別和單一藥物抗藥性!$T$6,性別和單一藥物抗藥性!$AA$6,性別和單一藥物抗藥性!$AH$6,性別和單一藥物抗藥性!$AO$6,性別和單一藥物抗藥性!$AV$6)</c:f>
              <c:numCache>
                <c:formatCode>General</c:formatCode>
                <c:ptCount val="7"/>
                <c:pt idx="0">
                  <c:v>0.53621169916434541</c:v>
                </c:pt>
                <c:pt idx="1">
                  <c:v>0.16573816155988857</c:v>
                </c:pt>
                <c:pt idx="2">
                  <c:v>0.19846796657381616</c:v>
                </c:pt>
                <c:pt idx="3">
                  <c:v>2.3676880222841225E-2</c:v>
                </c:pt>
                <c:pt idx="4">
                  <c:v>7.5208913649025072E-2</c:v>
                </c:pt>
                <c:pt idx="5">
                  <c:v>0.13370473537604458</c:v>
                </c:pt>
                <c:pt idx="6">
                  <c:v>0.5341225626740947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00"/>
        <c:axId val="452358464"/>
        <c:axId val="452358072"/>
      </c:barChart>
      <c:catAx>
        <c:axId val="45235846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5400000" spcFirstLastPara="1" vertOverflow="ellipsis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Arial Unicode MS" panose="020B0604020202020204" pitchFamily="34" charset="-120"/>
                <a:cs typeface="Arial" panose="020B0604020202020204" pitchFamily="34" charset="0"/>
              </a:defRPr>
            </a:pPr>
            <a:endParaRPr lang="zh-TW"/>
          </a:p>
        </c:txPr>
        <c:crossAx val="452358072"/>
        <c:crosses val="autoZero"/>
        <c:auto val="1"/>
        <c:lblAlgn val="ctr"/>
        <c:lblOffset val="100"/>
        <c:noMultiLvlLbl val="0"/>
      </c:catAx>
      <c:valAx>
        <c:axId val="452358072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Arial Unicode MS" panose="020B0604020202020204" pitchFamily="34" charset="-120"/>
                    <a:cs typeface="Arial" panose="020B0604020202020204" pitchFamily="34" charset="0"/>
                  </a:defRPr>
                </a:pPr>
                <a:r>
                  <a:rPr lang="en-US"/>
                  <a:t>Non-susceptible rate</a:t>
                </a:r>
                <a:endParaRPr lang="zh-TW"/>
              </a:p>
            </c:rich>
          </c:tx>
          <c:layout>
            <c:manualLayout>
              <c:xMode val="edge"/>
              <c:yMode val="edge"/>
              <c:x val="3.9365709924932381E-3"/>
              <c:y val="5.1690212579277812E-2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Arial Unicode MS" panose="020B0604020202020204" pitchFamily="34" charset="-120"/>
                  <a:cs typeface="Arial" panose="020B0604020202020204" pitchFamily="34" charset="0"/>
                </a:defRPr>
              </a:pPr>
              <a:endParaRPr lang="zh-TW"/>
            </a:p>
          </c:txPr>
        </c:title>
        <c:numFmt formatCode="0%" sourceLinked="0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Arial Unicode MS" panose="020B0604020202020204" pitchFamily="34" charset="-120"/>
                <a:cs typeface="Arial" panose="020B0604020202020204" pitchFamily="34" charset="0"/>
              </a:defRPr>
            </a:pPr>
            <a:endParaRPr lang="zh-TW"/>
          </a:p>
        </c:txPr>
        <c:crossAx val="45235846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layout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400" b="0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Arial Unicode MS" panose="020B0604020202020204" pitchFamily="34" charset="-120"/>
              <a:cs typeface="Arial" panose="020B0604020202020204" pitchFamily="34" charset="0"/>
            </a:defRPr>
          </a:pPr>
          <a:endParaRPr lang="zh-TW"/>
        </a:p>
      </c:txPr>
    </c:legend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1400">
          <a:solidFill>
            <a:schemeClr val="tx1"/>
          </a:solidFill>
          <a:latin typeface="Arial" panose="020B0604020202020204" pitchFamily="34" charset="0"/>
          <a:ea typeface="Arial Unicode MS" panose="020B0604020202020204" pitchFamily="34" charset="-120"/>
          <a:cs typeface="Arial" panose="020B0604020202020204" pitchFamily="34" charset="0"/>
        </a:defRPr>
      </a:pPr>
      <a:endParaRPr lang="zh-TW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TW" altLang="en-US" smtClean="0"/>
              <a:t>按一下以編輯母片副標題樣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916FF3-EC6F-4384-83EE-D1B9E4DE6173}" type="datetimeFigureOut">
              <a:rPr lang="zh-TW" altLang="en-US" smtClean="0"/>
              <a:t>2020/3/2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2756B7-59D5-49D3-8B1A-DF5E309A7ED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51395883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916FF3-EC6F-4384-83EE-D1B9E4DE6173}" type="datetimeFigureOut">
              <a:rPr lang="zh-TW" altLang="en-US" smtClean="0"/>
              <a:t>2020/3/2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2756B7-59D5-49D3-8B1A-DF5E309A7ED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7593534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916FF3-EC6F-4384-83EE-D1B9E4DE6173}" type="datetimeFigureOut">
              <a:rPr lang="zh-TW" altLang="en-US" smtClean="0"/>
              <a:t>2020/3/2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2756B7-59D5-49D3-8B1A-DF5E309A7ED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11947244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916FF3-EC6F-4384-83EE-D1B9E4DE6173}" type="datetimeFigureOut">
              <a:rPr lang="zh-TW" altLang="en-US" smtClean="0"/>
              <a:t>2020/3/2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2756B7-59D5-49D3-8B1A-DF5E309A7ED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6856532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916FF3-EC6F-4384-83EE-D1B9E4DE6173}" type="datetimeFigureOut">
              <a:rPr lang="zh-TW" altLang="en-US" smtClean="0"/>
              <a:t>2020/3/2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2756B7-59D5-49D3-8B1A-DF5E309A7ED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39008265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916FF3-EC6F-4384-83EE-D1B9E4DE6173}" type="datetimeFigureOut">
              <a:rPr lang="zh-TW" altLang="en-US" smtClean="0"/>
              <a:t>2020/3/29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2756B7-59D5-49D3-8B1A-DF5E309A7ED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9757870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916FF3-EC6F-4384-83EE-D1B9E4DE6173}" type="datetimeFigureOut">
              <a:rPr lang="zh-TW" altLang="en-US" smtClean="0"/>
              <a:t>2020/3/29</a:t>
            </a:fld>
            <a:endParaRPr lang="zh-TW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2756B7-59D5-49D3-8B1A-DF5E309A7ED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6546456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916FF3-EC6F-4384-83EE-D1B9E4DE6173}" type="datetimeFigureOut">
              <a:rPr lang="zh-TW" altLang="en-US" smtClean="0"/>
              <a:t>2020/3/29</a:t>
            </a:fld>
            <a:endParaRPr lang="zh-TW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2756B7-59D5-49D3-8B1A-DF5E309A7ED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93163863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916FF3-EC6F-4384-83EE-D1B9E4DE6173}" type="datetimeFigureOut">
              <a:rPr lang="zh-TW" altLang="en-US" smtClean="0"/>
              <a:t>2020/3/29</a:t>
            </a:fld>
            <a:endParaRPr lang="zh-TW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2756B7-59D5-49D3-8B1A-DF5E309A7ED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2092411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916FF3-EC6F-4384-83EE-D1B9E4DE6173}" type="datetimeFigureOut">
              <a:rPr lang="zh-TW" altLang="en-US" smtClean="0"/>
              <a:t>2020/3/29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2756B7-59D5-49D3-8B1A-DF5E309A7ED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50262745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TW" altLang="en-US" smtClean="0"/>
              <a:t>按一下圖示以新增圖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TW" altLang="en-US" smtClean="0"/>
              <a:t>按一下以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2916FF3-EC6F-4384-83EE-D1B9E4DE6173}" type="datetimeFigureOut">
              <a:rPr lang="zh-TW" altLang="en-US" smtClean="0"/>
              <a:t>2020/3/29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B2756B7-59D5-49D3-8B1A-DF5E309A7ED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533457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 smtClean="0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按一下以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2916FF3-EC6F-4384-83EE-D1B9E4DE6173}" type="datetimeFigureOut">
              <a:rPr lang="zh-TW" altLang="en-US" smtClean="0"/>
              <a:t>2020/3/29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2756B7-59D5-49D3-8B1A-DF5E309A7ED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002816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字方塊 4"/>
          <p:cNvSpPr txBox="1"/>
          <p:nvPr/>
        </p:nvSpPr>
        <p:spPr>
          <a:xfrm>
            <a:off x="0" y="0"/>
            <a:ext cx="10885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dirty="0" smtClean="0">
                <a:latin typeface="Arial" panose="020B0604020202020204" pitchFamily="34" charset="0"/>
                <a:cs typeface="Arial" panose="020B0604020202020204" pitchFamily="34" charset="0"/>
              </a:rPr>
              <a:t>S2A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9" name="圖表 28"/>
          <p:cNvGraphicFramePr>
            <a:graphicFrameLocks/>
          </p:cNvGraphicFramePr>
          <p:nvPr>
            <p:extLst/>
          </p:nvPr>
        </p:nvGraphicFramePr>
        <p:xfrm>
          <a:off x="186614" y="5547303"/>
          <a:ext cx="6480000" cy="386599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cxnSp>
        <p:nvCxnSpPr>
          <p:cNvPr id="7" name="直線接點 6"/>
          <p:cNvCxnSpPr/>
          <p:nvPr/>
        </p:nvCxnSpPr>
        <p:spPr>
          <a:xfrm>
            <a:off x="2832100" y="5778500"/>
            <a:ext cx="381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0" name="文字方塊 29"/>
          <p:cNvSpPr txBox="1"/>
          <p:nvPr/>
        </p:nvSpPr>
        <p:spPr>
          <a:xfrm>
            <a:off x="0" y="4914900"/>
            <a:ext cx="108857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dirty="0" smtClean="0">
                <a:latin typeface="Arial" panose="020B0604020202020204" pitchFamily="34" charset="0"/>
                <a:cs typeface="Arial" panose="020B0604020202020204" pitchFamily="34" charset="0"/>
              </a:rPr>
              <a:t>S</a:t>
            </a:r>
            <a:r>
              <a:rPr lang="en-US" altLang="zh-TW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altLang="zh-TW" dirty="0" smtClean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TW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文字方塊 1"/>
          <p:cNvSpPr txBox="1"/>
          <p:nvPr/>
        </p:nvSpPr>
        <p:spPr>
          <a:xfrm rot="16200000">
            <a:off x="1122463" y="7084248"/>
            <a:ext cx="5212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946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文字方塊 8"/>
          <p:cNvSpPr txBox="1"/>
          <p:nvPr/>
        </p:nvSpPr>
        <p:spPr>
          <a:xfrm rot="16200000">
            <a:off x="1312963" y="7081708"/>
            <a:ext cx="5212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2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145</a:t>
            </a:r>
            <a:endParaRPr lang="zh-TW" altLang="en-US" sz="12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字方塊 9"/>
          <p:cNvSpPr txBox="1"/>
          <p:nvPr/>
        </p:nvSpPr>
        <p:spPr>
          <a:xfrm rot="16200000">
            <a:off x="1907323" y="7084248"/>
            <a:ext cx="5212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746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文字方塊 10"/>
          <p:cNvSpPr txBox="1"/>
          <p:nvPr/>
        </p:nvSpPr>
        <p:spPr>
          <a:xfrm rot="16200000">
            <a:off x="2097823" y="7081708"/>
            <a:ext cx="5212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2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345</a:t>
            </a:r>
            <a:endParaRPr lang="zh-TW" altLang="en-US" sz="12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文字方塊 11"/>
          <p:cNvSpPr txBox="1"/>
          <p:nvPr/>
        </p:nvSpPr>
        <p:spPr>
          <a:xfrm rot="16200000">
            <a:off x="2684563" y="7084248"/>
            <a:ext cx="5212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652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字方塊 12"/>
          <p:cNvSpPr txBox="1"/>
          <p:nvPr/>
        </p:nvSpPr>
        <p:spPr>
          <a:xfrm rot="16200000">
            <a:off x="2875063" y="7081708"/>
            <a:ext cx="5212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2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439</a:t>
            </a:r>
            <a:endParaRPr lang="zh-TW" altLang="en-US" sz="12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字方塊 13"/>
          <p:cNvSpPr txBox="1"/>
          <p:nvPr/>
        </p:nvSpPr>
        <p:spPr>
          <a:xfrm rot="16200000">
            <a:off x="3461803" y="7084248"/>
            <a:ext cx="5212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2035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字方塊 14"/>
          <p:cNvSpPr txBox="1"/>
          <p:nvPr/>
        </p:nvSpPr>
        <p:spPr>
          <a:xfrm rot="16200000">
            <a:off x="3652303" y="7081708"/>
            <a:ext cx="5212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2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56</a:t>
            </a:r>
            <a:endParaRPr lang="zh-TW" altLang="en-US" sz="12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" name="文字方塊 15"/>
          <p:cNvSpPr txBox="1"/>
          <p:nvPr/>
        </p:nvSpPr>
        <p:spPr>
          <a:xfrm rot="16200000">
            <a:off x="4231423" y="7084248"/>
            <a:ext cx="5212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933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文字方塊 16"/>
          <p:cNvSpPr txBox="1"/>
          <p:nvPr/>
        </p:nvSpPr>
        <p:spPr>
          <a:xfrm rot="16200000">
            <a:off x="4421923" y="7081708"/>
            <a:ext cx="5212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2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58</a:t>
            </a:r>
            <a:endParaRPr lang="zh-TW" altLang="en-US" sz="12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文字方塊 17"/>
          <p:cNvSpPr txBox="1"/>
          <p:nvPr/>
        </p:nvSpPr>
        <p:spPr>
          <a:xfrm rot="16200000">
            <a:off x="5016283" y="7076628"/>
            <a:ext cx="5212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1796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" name="文字方塊 18"/>
          <p:cNvSpPr txBox="1"/>
          <p:nvPr/>
        </p:nvSpPr>
        <p:spPr>
          <a:xfrm rot="16200000">
            <a:off x="5206783" y="7074088"/>
            <a:ext cx="5212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2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95</a:t>
            </a:r>
            <a:endParaRPr lang="zh-TW" altLang="en-US" sz="12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" name="文字方塊 19"/>
          <p:cNvSpPr txBox="1"/>
          <p:nvPr/>
        </p:nvSpPr>
        <p:spPr>
          <a:xfrm rot="16200000">
            <a:off x="5785903" y="7091868"/>
            <a:ext cx="5212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944</a:t>
            </a:r>
            <a:endParaRPr lang="zh-TW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文字方塊 20"/>
          <p:cNvSpPr txBox="1"/>
          <p:nvPr/>
        </p:nvSpPr>
        <p:spPr>
          <a:xfrm rot="16200000">
            <a:off x="5976403" y="7089328"/>
            <a:ext cx="52121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200" dirty="0" smtClean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147</a:t>
            </a:r>
            <a:endParaRPr lang="zh-TW" altLang="en-US" sz="1200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22" name="圖表 21"/>
          <p:cNvGraphicFramePr>
            <a:graphicFrameLocks/>
          </p:cNvGraphicFramePr>
          <p:nvPr>
            <p:extLst/>
          </p:nvPr>
        </p:nvGraphicFramePr>
        <p:xfrm>
          <a:off x="222267" y="514607"/>
          <a:ext cx="6397485" cy="386599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23" name="文字方塊 22"/>
          <p:cNvSpPr txBox="1"/>
          <p:nvPr/>
        </p:nvSpPr>
        <p:spPr>
          <a:xfrm>
            <a:off x="2622875" y="5523854"/>
            <a:ext cx="79945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zh-TW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= 0.007</a:t>
            </a:r>
            <a:endParaRPr lang="zh-TW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723006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 佈景主題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佈景主題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佈景主題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119</TotalTime>
  <Words>22</Words>
  <Application>Microsoft Office PowerPoint</Application>
  <PresentationFormat>A4 紙張 (210x297 公釐)</PresentationFormat>
  <Paragraphs>19</Paragraphs>
  <Slides>1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5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1</vt:i4>
      </vt:variant>
    </vt:vector>
  </HeadingPairs>
  <TitlesOfParts>
    <vt:vector size="7" baseType="lpstr">
      <vt:lpstr>Arial Unicode MS</vt:lpstr>
      <vt:lpstr>新細明體</vt:lpstr>
      <vt:lpstr>Arial</vt:lpstr>
      <vt:lpstr>Calibri</vt:lpstr>
      <vt:lpstr>Calibri Light</vt:lpstr>
      <vt:lpstr>Office 佈景主題</vt:lpstr>
      <vt:lpstr>PowerPoint 簡報</vt:lpstr>
    </vt:vector>
  </TitlesOfParts>
  <Company>Toshiba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chenghsunho</dc:creator>
  <cp:lastModifiedBy>HP 250</cp:lastModifiedBy>
  <cp:revision>235</cp:revision>
  <cp:lastPrinted>2018-07-02T08:11:55Z</cp:lastPrinted>
  <dcterms:created xsi:type="dcterms:W3CDTF">2017-10-31T07:54:33Z</dcterms:created>
  <dcterms:modified xsi:type="dcterms:W3CDTF">2020-03-29T02:20:17Z</dcterms:modified>
</cp:coreProperties>
</file>